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97675" cy="987425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7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73902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44825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9975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86483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47713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69473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69538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44815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84482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245806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20517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36FAD-C645-4E2D-BCA0-BF56EB24FF53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39D57-857F-48C0-ACAB-2C115F7814C5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43836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0" y="0"/>
            <a:ext cx="74361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5: Figure S5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Starvation blocks induced adipogenesis of primary stromal cells. </a:t>
            </a:r>
            <a:endParaRPr lang="de-A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979712" y="571784"/>
            <a:ext cx="6077450" cy="5012342"/>
            <a:chOff x="1979712" y="571784"/>
            <a:chExt cx="6077450" cy="5012342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9712" y="3311540"/>
              <a:ext cx="2797850" cy="22725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2874" y="3311540"/>
              <a:ext cx="2804288" cy="22725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9712" y="884267"/>
              <a:ext cx="2797850" cy="2245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2874" y="884266"/>
              <a:ext cx="2804288" cy="2245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2839124" y="576489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oxia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44961" y="571784"/>
              <a:ext cx="12079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rvation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95536" y="5877272"/>
            <a:ext cx="81369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Legend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Prolonged stress (starvation) blocks induced adipocyte differentiation of primary stromal cells. ORO staining (lower panel) was performed at d.21. Representative pictures of 4 independent experiments</a:t>
            </a:r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6141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ak Zvenyslava</dc:creator>
  <cp:lastModifiedBy>Husak Zvenyslava</cp:lastModifiedBy>
  <cp:revision>12</cp:revision>
  <cp:lastPrinted>2016-09-23T14:25:49Z</cp:lastPrinted>
  <dcterms:created xsi:type="dcterms:W3CDTF">2016-06-21T08:06:23Z</dcterms:created>
  <dcterms:modified xsi:type="dcterms:W3CDTF">2016-10-19T11:58:51Z</dcterms:modified>
</cp:coreProperties>
</file>